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073"/>
  </p:normalViewPr>
  <p:slideViewPr>
    <p:cSldViewPr snapToGrid="0" snapToObjects="1">
      <p:cViewPr varScale="1">
        <p:scale>
          <a:sx n="107" d="100"/>
          <a:sy n="107" d="100"/>
        </p:scale>
        <p:origin x="73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0A25C6-1EE5-B64C-8597-6A19C282C63F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888AC7-8D12-1E47-A4A9-4B3E0627D2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537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endix Table 1. Risk stratification of complexity for repair of myxomatous mitral valve. Complexity score = sum of weights. Complexity strata (by complexity score): simple, 1; intermediate, 2-4; complex, ≥5. 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C8626B-2075-A243-A244-780E0EDA612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9967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AC0176E-951B-7543-82C8-CFC72451185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04C1678-1C44-6B49-84B3-13D9F12726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1DA73C-4BE3-FD49-AB28-90549160A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66A5DF-E0A6-1F47-8978-2C93A5E8D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72BB6E-F9E2-454C-8BAC-193D35337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84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65EADD-15A1-5D4A-AEE2-59F3CE5411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02A07C5-3686-B641-9947-66E2EE891D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959304-5967-794C-B3A6-14C1258F2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6FD05B-B793-A243-ABD8-9146426B7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AEE4FD8-9C8A-E54A-9CA3-F105093D9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4500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07AF76F-A6E8-3E44-82BF-9F67196854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6B31371-E4EE-B445-BEB4-58A950686B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2BE45B-D6DF-B14E-8719-D32AA9719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983A47-B782-F344-84C6-DB786695F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5DB56B-7231-1E41-AD3C-1E7C928B8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72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60F520-BD7E-EC40-9BC1-03011CDE2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99B44E4-FEAF-AB46-813C-E515F2290ED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47C350-B852-3345-AC6F-83C1B65AD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32C204D-7C12-7041-B159-B8E148C4BA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D55A3B-EC4D-374D-B914-57411BB4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8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94D4B0C-0142-954E-81A0-3F158EAB3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B357CB-8917-554A-9508-3EA41208FA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2CC8EAC-55E2-D94E-899C-6D89023080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83ECDB8-A1AE-574D-891C-DDE5EC72F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5244AA-3616-9E41-B956-E2C294E78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460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641AE7-974F-414D-949B-552D0BE59D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EFDCEF-FF74-294D-B7B2-3D75F31960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E36898-8012-8940-A352-67CBDF5CA2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C9AE39-4037-2542-B6E9-2F7B056A4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BC24F14-A369-0041-802B-F13F5B1645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D47B4DD-2164-C746-A175-13EC9D98D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282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ED3E78-93FF-A348-8F96-87DF01C110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0506E18-4C64-3C49-B060-03B4EEF2B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874364-90C1-6040-BFD3-7F5B003D31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507D323-7778-0F40-85F6-1E5E68E751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8E7F556-14BC-C041-8E17-D01E7728E1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7630499-0906-9643-A17C-EFCA3629C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9F87903-CFED-9A4E-AC3F-4EDF8C7B2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5C47542-5FE2-C442-AA97-D2AAF98AD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391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724C0E-428B-4246-8FF1-2CAD7F3B8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3485D90-CE2C-CE43-8540-A63472A75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C4FDFED-61DE-7F4B-A1CA-AD14008F7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83B67A5-3A40-2A4F-ACA0-5AC8AC822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552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05C5A44-FB17-034E-80D8-60209B1B9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F6A0E29-285C-E04C-86DA-F9A6E03E6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2E9054C-BE7B-8F4F-B03E-24101F044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733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743465-709B-474B-AE14-F07CCBDBE2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BAC5E13-99F5-1B4F-901E-3ED09E53CF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A36F9F3-095C-A949-A59F-2F735CC7C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6DE913B-FB8B-1847-BD89-90705CE35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671053-166B-FB4E-B8B9-427F5CCA8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192EFCB-9530-7842-908F-8399427438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747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8CFA15-391A-4145-924A-6A9851ED7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5310A87-4BBF-2845-B0E0-2AA1B6A075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DDABA72-2335-AA42-BB02-94C0FD1910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A2E497F-82C4-E843-9D4E-3FE36B69C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14AC5AA-C0AE-7149-AADA-310325D6E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8BB0CD-207C-D048-B1C5-82A7D9AAD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8728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E0F1DFB-A1F4-744C-90FA-85EFD9D7E7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F31B04-3B62-0D45-A839-E1092FD553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BB1CA8-C560-5B43-BCB1-2C02CA23FE5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CC020-6BB5-1340-80CD-C73DF6841CB6}" type="datetimeFigureOut">
              <a:rPr kumimoji="1" lang="ja-JP" altLang="en-US" smtClean="0"/>
              <a:t>2020/9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A1D6E8-BBE2-844E-BD90-2339FBC316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8FB874-836B-C84B-8036-B1DF8484DF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215B2-DA92-C842-BD2D-489CB9E5E31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37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FC228B4A-1E8F-7E46-96B6-E922673D43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2364623"/>
              </p:ext>
            </p:extLst>
          </p:nvPr>
        </p:nvGraphicFramePr>
        <p:xfrm>
          <a:off x="3285412" y="831405"/>
          <a:ext cx="5982766" cy="518557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4967202">
                  <a:extLst>
                    <a:ext uri="{9D8B030D-6E8A-4147-A177-3AD203B41FA5}">
                      <a16:colId xmlns:a16="http://schemas.microsoft.com/office/drawing/2014/main" val="1036768959"/>
                    </a:ext>
                  </a:extLst>
                </a:gridCol>
                <a:gridCol w="1015564">
                  <a:extLst>
                    <a:ext uri="{9D8B030D-6E8A-4147-A177-3AD203B41FA5}">
                      <a16:colId xmlns:a16="http://schemas.microsoft.com/office/drawing/2014/main" val="401516954"/>
                    </a:ext>
                  </a:extLst>
                </a:gridCol>
              </a:tblGrid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b="1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Anatomic factors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" sz="1050" b="1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Points</a:t>
                      </a:r>
                      <a:endParaRPr lang="en" sz="1050" b="1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729837871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Segment prolapse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277616992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P1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344014981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P2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60430492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P3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1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274746288"/>
                  </a:ext>
                </a:extLst>
              </a:tr>
              <a:tr h="166835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A1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436962045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A2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290275444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  A3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48655271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Anterolateral commissure prolapse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26664154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Posteromedial commissure prolapse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353420062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Any leaflet restriction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609675427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Papillary muscle or leaflet calcification without annular involvement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2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968029303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Annular calcification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119987391"/>
                  </a:ext>
                </a:extLst>
              </a:tr>
              <a:tr h="386057">
                <a:tc>
                  <a:txBody>
                    <a:bodyPr/>
                    <a:lstStyle/>
                    <a:p>
                      <a:pPr algn="l" fontAlgn="ctr"/>
                      <a:r>
                        <a:rPr lang="en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 Previous mitral valve repair</a:t>
                      </a:r>
                      <a:endParaRPr lang="en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50" u="none" strike="noStrike" dirty="0">
                          <a:effectLst/>
                          <a:latin typeface="Helvetica" pitchFamily="2" charset="0"/>
                          <a:ea typeface="Hiragino Kaku Gothic Pro W3" panose="020B0300000000000000" pitchFamily="34" charset="-128"/>
                        </a:rPr>
                        <a:t>3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Helvetica" pitchFamily="2" charset="0"/>
                        <a:ea typeface="Hiragino Kaku Gothic Pro W3" panose="020B0300000000000000" pitchFamily="34" charset="-128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9917983"/>
                  </a:ext>
                </a:extLst>
              </a:tr>
            </a:tbl>
          </a:graphicData>
        </a:graphic>
      </p:graphicFrame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396C3AB8-B4F0-0245-B23C-76D3C7ED96E7}"/>
              </a:ext>
            </a:extLst>
          </p:cNvPr>
          <p:cNvCxnSpPr>
            <a:cxnSpLocks/>
          </p:cNvCxnSpPr>
          <p:nvPr/>
        </p:nvCxnSpPr>
        <p:spPr bwMode="auto">
          <a:xfrm>
            <a:off x="3285410" y="1205582"/>
            <a:ext cx="5982768" cy="0"/>
          </a:xfrm>
          <a:prstGeom prst="line">
            <a:avLst/>
          </a:prstGeom>
          <a:solidFill>
            <a:schemeClr val="accent1"/>
          </a:solidFill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11E087E-0090-394B-8E21-862490AA4D3D}"/>
              </a:ext>
            </a:extLst>
          </p:cNvPr>
          <p:cNvSpPr txBox="1"/>
          <p:nvPr/>
        </p:nvSpPr>
        <p:spPr>
          <a:xfrm>
            <a:off x="936978" y="338667"/>
            <a:ext cx="20233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/>
              <a:t>Appendix Table 1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31282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06</Words>
  <Application>Microsoft Macintosh PowerPoint</Application>
  <PresentationFormat>ワイド画面</PresentationFormat>
  <Paragraphs>3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山 泰介</dc:creator>
  <cp:lastModifiedBy>中山 泰介</cp:lastModifiedBy>
  <cp:revision>4</cp:revision>
  <dcterms:created xsi:type="dcterms:W3CDTF">2020-06-25T15:20:48Z</dcterms:created>
  <dcterms:modified xsi:type="dcterms:W3CDTF">2020-09-09T14:20:08Z</dcterms:modified>
</cp:coreProperties>
</file>